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C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28"/>
    <p:restoredTop sz="94694"/>
  </p:normalViewPr>
  <p:slideViewPr>
    <p:cSldViewPr snapToGrid="0" snapToObjects="1">
      <p:cViewPr varScale="1">
        <p:scale>
          <a:sx n="86" d="100"/>
          <a:sy n="86" d="100"/>
        </p:scale>
        <p:origin x="279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749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78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663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752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595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7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56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335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75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32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37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918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33530C-D703-3640-9FC2-921686DBF6D1}"/>
              </a:ext>
            </a:extLst>
          </p:cNvPr>
          <p:cNvSpPr txBox="1"/>
          <p:nvPr/>
        </p:nvSpPr>
        <p:spPr>
          <a:xfrm>
            <a:off x="180015" y="521118"/>
            <a:ext cx="6616700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Supplementary Figure 3 </a:t>
            </a:r>
          </a:p>
          <a:p>
            <a:r>
              <a:rPr lang="en-US" sz="1200"/>
              <a:t>Correlation of total serum Immunoglobulin compared to time since diagnosis amongst untreated patient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C5007C0-DE8A-4142-94BB-1546E8583953}"/>
              </a:ext>
            </a:extLst>
          </p:cNvPr>
          <p:cNvSpPr txBox="1"/>
          <p:nvPr/>
        </p:nvSpPr>
        <p:spPr>
          <a:xfrm>
            <a:off x="255562" y="3941196"/>
            <a:ext cx="56880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orrelation of serum immunoglobulin levels in untreated patients compared to time since diagnosis is shown; Spearman’s rank correlation:  IgA (r=-0.019; p=0.759) IgG (r=-0.07; p=0.23) IgM (r=-0.15; p=0.01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B897831-5DB6-8941-8B8D-34F532531F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831" y="1636235"/>
            <a:ext cx="6616700" cy="2057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7438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23</TotalTime>
  <Words>66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arry (School of Immunity and Infection)</dc:creator>
  <cp:lastModifiedBy>Helen Parry (School of Immunity and Infection)</cp:lastModifiedBy>
  <cp:revision>83</cp:revision>
  <dcterms:created xsi:type="dcterms:W3CDTF">2021-08-29T12:31:11Z</dcterms:created>
  <dcterms:modified xsi:type="dcterms:W3CDTF">2021-10-10T20:27:28Z</dcterms:modified>
</cp:coreProperties>
</file>